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D484F6-21D3-45B2-B70E-E9AFF00925F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67DE94-5268-4D99-88FA-67048901C8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5FDE24-2110-4926-B117-C1D7B7DB029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0D22A1-1933-40CF-B5ED-9B17C2D29D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7D27A5-AF40-4DB0-AD07-113DD8F6FD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FD1A7-B2EA-40D5-84EF-5A81AA0807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C0E05B-1BF0-427C-BDF0-9087ED69C2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51DE3-F874-4E75-A5E4-332148A749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5EFD8E-B0D7-423C-AB7E-2C7914E7B4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27559C-3C43-4831-A652-335C20F8F1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BAC5B8-307F-41D0-B87B-257DC7087E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0BE79D-298D-451D-BA45-38CE8CBC64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3687BA-498A-4FEE-8A00-0C7D7A0529D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package" Target="../embeddings/oleObject4.xlsx"/><Relationship Id="rId8" Type="http://schemas.openxmlformats.org/officeDocument/2006/relationships/image" Target="../media/image4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Chart 13"/>
          <p:cNvGraphicFramePr/>
          <p:nvPr/>
        </p:nvGraphicFramePr>
        <p:xfrm>
          <a:off x="523800" y="4257720"/>
          <a:ext cx="3767040" cy="19620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Chart 1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23800" y="4257720"/>
                    <a:ext cx="3767040" cy="1962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Chart 3"/>
          <p:cNvGraphicFramePr/>
          <p:nvPr/>
        </p:nvGraphicFramePr>
        <p:xfrm>
          <a:off x="5029200" y="4248000"/>
          <a:ext cx="3767040" cy="196236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Char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5029200" y="4248000"/>
                    <a:ext cx="3767040" cy="1962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Chart 27"/>
          <p:cNvGraphicFramePr/>
          <p:nvPr/>
        </p:nvGraphicFramePr>
        <p:xfrm>
          <a:off x="523800" y="1866960"/>
          <a:ext cx="3767040" cy="196200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46" name="Chart 27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523800" y="1866960"/>
                    <a:ext cx="3767040" cy="1962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Chart 19"/>
          <p:cNvGraphicFramePr/>
          <p:nvPr/>
        </p:nvGraphicFramePr>
        <p:xfrm>
          <a:off x="5057640" y="1905120"/>
          <a:ext cx="3767400" cy="196200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48" name="Chart 19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5057640" y="1905120"/>
                    <a:ext cx="3767400" cy="1962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9" name=""/>
          <p:cNvGraphicFramePr/>
          <p:nvPr/>
        </p:nvGraphicFramePr>
        <p:xfrm>
          <a:off x="438120" y="763560"/>
          <a:ext cx="6419880" cy="273240"/>
        </p:xfrm>
        <a:graphic>
          <a:graphicData uri="http://schemas.openxmlformats.org/drawingml/2006/table">
            <a:tbl>
              <a:tblPr/>
              <a:tblGrid>
                <a:gridCol w="6419880"/>
              </a:tblGrid>
              <a:tr h="273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igure S14. Distribution of repetitive elements and small RNAs proximal to gene sequences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0" name=""/>
          <p:cNvSpPr/>
          <p:nvPr/>
        </p:nvSpPr>
        <p:spPr>
          <a:xfrm>
            <a:off x="271440" y="1747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71440" y="41385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786200" y="17384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786200" y="4129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15T05:23:06Z</dcterms:created>
  <dc:creator>fushengw</dc:creator>
  <dc:description/>
  <dc:language>en-US</dc:language>
  <cp:lastModifiedBy>fushengw</cp:lastModifiedBy>
  <dcterms:modified xsi:type="dcterms:W3CDTF">2009-10-15T05:28:18Z</dcterms:modified>
  <cp:revision>6</cp:revision>
  <dc:subject/>
  <dc:title>Slide 1</dc:title>
</cp:coreProperties>
</file>